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98A1273-9FF7-4A37-8AD4-B5EAA5F64B1C}" type="slidenum">
              <a:rPr b="0" lang="zh-CN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64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zh-CN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灯片编号占位符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0D33FB2-972C-406A-8968-915A9289C9DD}" type="slidenum">
              <a:rPr b="0" lang="zh-CN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11C78F-402F-47E1-9CB9-CBB1FF31A69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F89746-960A-47B3-8730-F7AE6FC5FBC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85EDEB-FDC2-4C20-B9E6-DEB056CFB11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024AC4-C580-40CA-BF7F-1D0C0304DA3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1803F3-6B08-4DBB-9FB4-D5FD9F8B25A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DAE4EF-E0CB-4AEB-8E7A-DABAA010877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E8C629-4E85-4859-8364-573FCF6552C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B61323-5071-4C71-B81E-A449D0A9DAD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B0A5FF-70A7-4504-9297-8B0036967ED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E1B956-6954-4F18-B05C-C5E4C0A71ED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4D99C9-DB70-4427-AE76-E92FAAB6D61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84C5F8-9B00-4853-AB09-BFE78786E66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9F51015-C1E5-40AB-B3EE-1495B8EEECC1}" type="slidenum">
              <a:rPr b="0" lang="zh-C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图示 1" descr=""/>
          <p:cNvPicPr/>
          <p:nvPr/>
        </p:nvPicPr>
        <p:blipFill>
          <a:blip r:embed="rId1"/>
          <a:stretch/>
        </p:blipFill>
        <p:spPr>
          <a:xfrm>
            <a:off x="-19080" y="-1182600"/>
            <a:ext cx="9182160" cy="5468760"/>
          </a:xfrm>
          <a:prstGeom prst="rect">
            <a:avLst/>
          </a:prstGeom>
          <a:ln w="0">
            <a:noFill/>
          </a:ln>
        </p:spPr>
      </p:pic>
      <p:sp>
        <p:nvSpPr>
          <p:cNvPr id="49" name="TextBox 3"/>
          <p:cNvSpPr/>
          <p:nvPr/>
        </p:nvSpPr>
        <p:spPr>
          <a:xfrm>
            <a:off x="4716360" y="3141720"/>
            <a:ext cx="428328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Selected 2-5 provinces from each region based on population size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直接连接符 10"/>
          <p:cNvSpPr/>
          <p:nvPr/>
        </p:nvSpPr>
        <p:spPr>
          <a:xfrm>
            <a:off x="755640" y="3213000"/>
            <a:ext cx="7632720" cy="0"/>
          </a:xfrm>
          <a:prstGeom prst="line">
            <a:avLst/>
          </a:prstGeom>
          <a:ln w="381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直接连接符 12"/>
          <p:cNvSpPr/>
          <p:nvPr/>
        </p:nvSpPr>
        <p:spPr>
          <a:xfrm>
            <a:off x="4572000" y="3213000"/>
            <a:ext cx="0" cy="503280"/>
          </a:xfrm>
          <a:prstGeom prst="line">
            <a:avLst/>
          </a:prstGeom>
          <a:ln w="381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直接连接符 20"/>
          <p:cNvSpPr/>
          <p:nvPr/>
        </p:nvSpPr>
        <p:spPr>
          <a:xfrm>
            <a:off x="755640" y="2997360"/>
            <a:ext cx="0" cy="215640"/>
          </a:xfrm>
          <a:prstGeom prst="line">
            <a:avLst/>
          </a:prstGeom>
          <a:ln w="381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直接连接符 21"/>
          <p:cNvSpPr/>
          <p:nvPr/>
        </p:nvSpPr>
        <p:spPr>
          <a:xfrm>
            <a:off x="8388360" y="2997360"/>
            <a:ext cx="0" cy="215640"/>
          </a:xfrm>
          <a:prstGeom prst="line">
            <a:avLst/>
          </a:prstGeom>
          <a:ln w="381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4" name="图示 23" descr=""/>
          <p:cNvPicPr/>
          <p:nvPr/>
        </p:nvPicPr>
        <p:blipFill>
          <a:blip r:embed="rId2"/>
          <a:stretch/>
        </p:blipFill>
        <p:spPr>
          <a:xfrm>
            <a:off x="463680" y="3608280"/>
            <a:ext cx="7643520" cy="2140200"/>
          </a:xfrm>
          <a:prstGeom prst="rect">
            <a:avLst/>
          </a:prstGeom>
          <a:ln w="0">
            <a:noFill/>
          </a:ln>
        </p:spPr>
      </p:pic>
      <p:sp>
        <p:nvSpPr>
          <p:cNvPr id="55" name="TextBox 24"/>
          <p:cNvSpPr/>
          <p:nvPr/>
        </p:nvSpPr>
        <p:spPr>
          <a:xfrm>
            <a:off x="4572000" y="5970600"/>
            <a:ext cx="44276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Randomized selected 1-4 hospitals from each city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6" name="组合 25"/>
          <p:cNvGrpSpPr/>
          <p:nvPr/>
        </p:nvGrpSpPr>
        <p:grpSpPr>
          <a:xfrm>
            <a:off x="1835280" y="6237360"/>
            <a:ext cx="5155920" cy="588960"/>
            <a:chOff x="1835280" y="6237360"/>
            <a:chExt cx="5155920" cy="588960"/>
          </a:xfrm>
        </p:grpSpPr>
        <p:sp>
          <p:nvSpPr>
            <p:cNvPr id="57" name="矩形 26"/>
            <p:cNvSpPr/>
            <p:nvPr/>
          </p:nvSpPr>
          <p:spPr>
            <a:xfrm>
              <a:off x="1835280" y="6237360"/>
              <a:ext cx="5155920" cy="588960"/>
            </a:xfrm>
            <a:prstGeom prst="rect">
              <a:avLst/>
            </a:prstGeom>
            <a:solidFill>
              <a:srgbClr val="4f81bd"/>
            </a:solidFill>
            <a:ln w="255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矩形 27"/>
            <p:cNvSpPr/>
            <p:nvPr/>
          </p:nvSpPr>
          <p:spPr>
            <a:xfrm>
              <a:off x="1835280" y="6237360"/>
              <a:ext cx="5155920" cy="588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0080" rIns="10080" tIns="10080" bIns="10080" anchor="ctr">
              <a:noAutofit/>
            </a:bodyPr>
            <a:p>
              <a:pPr algn="ctr">
                <a:lnSpc>
                  <a:spcPct val="90000"/>
                </a:lnSpc>
                <a:spcAft>
                  <a:spcPts val="700"/>
                </a:spcAft>
                <a:tabLst>
                  <a:tab algn="l" pos="0"/>
                  <a:tab algn="l" pos="711360"/>
                  <a:tab algn="l" pos="1422360"/>
                  <a:tab algn="l" pos="2133720"/>
                  <a:tab algn="l" pos="2844720"/>
                  <a:tab algn="l" pos="3556080"/>
                  <a:tab algn="l" pos="4267080"/>
                  <a:tab algn="l" pos="4978440"/>
                  <a:tab algn="l" pos="5689440"/>
                  <a:tab algn="l" pos="6400800"/>
                  <a:tab algn="l" pos="7112160"/>
                  <a:tab algn="l" pos="7823160"/>
                  <a:tab algn="l" pos="8534520"/>
                  <a:tab algn="l" pos="9245520"/>
                  <a:tab algn="l" pos="9956880"/>
                  <a:tab algn="l" pos="10667880"/>
                </a:tabLst>
              </a:pPr>
              <a:r>
                <a:rPr b="1" lang="en-US" sz="1600" spc="-1" strike="noStrike">
                  <a:solidFill>
                    <a:srgbClr val="ffffff"/>
                  </a:solidFill>
                  <a:latin typeface="Calibri"/>
                </a:rPr>
                <a:t>84 centers were selected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9" name="直接连接符 28"/>
          <p:cNvSpPr/>
          <p:nvPr/>
        </p:nvSpPr>
        <p:spPr>
          <a:xfrm>
            <a:off x="4356000" y="5950080"/>
            <a:ext cx="0" cy="287280"/>
          </a:xfrm>
          <a:prstGeom prst="line">
            <a:avLst/>
          </a:prstGeom>
          <a:ln w="381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直接连接符 29"/>
          <p:cNvSpPr/>
          <p:nvPr/>
        </p:nvSpPr>
        <p:spPr>
          <a:xfrm>
            <a:off x="1979640" y="5950080"/>
            <a:ext cx="4321080" cy="0"/>
          </a:xfrm>
          <a:prstGeom prst="line">
            <a:avLst/>
          </a:prstGeom>
          <a:ln w="381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直接连接符 30"/>
          <p:cNvSpPr/>
          <p:nvPr/>
        </p:nvSpPr>
        <p:spPr>
          <a:xfrm>
            <a:off x="1979640" y="5732640"/>
            <a:ext cx="0" cy="217440"/>
          </a:xfrm>
          <a:prstGeom prst="line">
            <a:avLst/>
          </a:prstGeom>
          <a:ln w="381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直接连接符 31"/>
          <p:cNvSpPr/>
          <p:nvPr/>
        </p:nvSpPr>
        <p:spPr>
          <a:xfrm>
            <a:off x="6300720" y="5732640"/>
            <a:ext cx="0" cy="217440"/>
          </a:xfrm>
          <a:prstGeom prst="line">
            <a:avLst/>
          </a:prstGeom>
          <a:ln w="381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8-21T02:47:43Z</dcterms:created>
  <dc:creator>USER</dc:creator>
  <dc:description/>
  <dc:language>en-US</dc:language>
  <cp:lastModifiedBy>USER</cp:lastModifiedBy>
  <dcterms:modified xsi:type="dcterms:W3CDTF">2012-08-21T03:46:17Z</dcterms:modified>
  <cp:revision>2</cp:revision>
  <dc:subject/>
  <dc:title>幻灯片 1</dc:title>
</cp:coreProperties>
</file>